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2" r:id="rId2"/>
    <p:sldId id="257" r:id="rId3"/>
    <p:sldId id="258" r:id="rId4"/>
    <p:sldId id="260" r:id="rId5"/>
    <p:sldId id="259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9714D4F-2694-4E0F-AE29-2B0693ADE5C5}" v="20" dt="2024-12-03T08:36:57.5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584"/>
    <p:restoredTop sz="95781"/>
  </p:normalViewPr>
  <p:slideViewPr>
    <p:cSldViewPr snapToGrid="0">
      <p:cViewPr varScale="1">
        <p:scale>
          <a:sx n="83" d="100"/>
          <a:sy n="83" d="100"/>
        </p:scale>
        <p:origin x="122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rdana Rankovic" userId="1d98097f-2084-4f17-864c-24cd5a9f1289" providerId="ADAL" clId="{79714D4F-2694-4E0F-AE29-2B0693ADE5C5}"/>
    <pc:docChg chg="custSel modSld">
      <pc:chgData name="Gordana Rankovic" userId="1d98097f-2084-4f17-864c-24cd5a9f1289" providerId="ADAL" clId="{79714D4F-2694-4E0F-AE29-2B0693ADE5C5}" dt="2024-12-03T08:37:04.440" v="70" actId="113"/>
      <pc:docMkLst>
        <pc:docMk/>
      </pc:docMkLst>
      <pc:sldChg chg="addSp delSp modSp mod">
        <pc:chgData name="Gordana Rankovic" userId="1d98097f-2084-4f17-864c-24cd5a9f1289" providerId="ADAL" clId="{79714D4F-2694-4E0F-AE29-2B0693ADE5C5}" dt="2024-12-03T08:35:25.101" v="22" actId="20578"/>
        <pc:sldMkLst>
          <pc:docMk/>
          <pc:sldMk cId="315382286" sldId="257"/>
        </pc:sldMkLst>
        <pc:spChg chg="mod">
          <ac:chgData name="Gordana Rankovic" userId="1d98097f-2084-4f17-864c-24cd5a9f1289" providerId="ADAL" clId="{79714D4F-2694-4E0F-AE29-2B0693ADE5C5}" dt="2024-12-03T08:35:25.101" v="22" actId="20578"/>
          <ac:spMkLst>
            <pc:docMk/>
            <pc:sldMk cId="315382286" sldId="257"/>
            <ac:spMk id="7" creationId="{29A57DC6-3454-EB16-8038-7F48F2662350}"/>
          </ac:spMkLst>
        </pc:spChg>
        <pc:graphicFrameChg chg="add del mod">
          <ac:chgData name="Gordana Rankovic" userId="1d98097f-2084-4f17-864c-24cd5a9f1289" providerId="ADAL" clId="{79714D4F-2694-4E0F-AE29-2B0693ADE5C5}" dt="2024-12-03T08:35:15.642" v="16"/>
          <ac:graphicFrameMkLst>
            <pc:docMk/>
            <pc:sldMk cId="315382286" sldId="257"/>
            <ac:graphicFrameMk id="4" creationId="{8465896F-18C4-C3CF-B496-F1AB17CB118A}"/>
          </ac:graphicFrameMkLst>
        </pc:graphicFrameChg>
      </pc:sldChg>
      <pc:sldChg chg="addSp delSp modSp mod">
        <pc:chgData name="Gordana Rankovic" userId="1d98097f-2084-4f17-864c-24cd5a9f1289" providerId="ADAL" clId="{79714D4F-2694-4E0F-AE29-2B0693ADE5C5}" dt="2024-12-03T08:35:50.402" v="34" actId="113"/>
        <pc:sldMkLst>
          <pc:docMk/>
          <pc:sldMk cId="2694073638" sldId="258"/>
        </pc:sldMkLst>
        <pc:spChg chg="mod">
          <ac:chgData name="Gordana Rankovic" userId="1d98097f-2084-4f17-864c-24cd5a9f1289" providerId="ADAL" clId="{79714D4F-2694-4E0F-AE29-2B0693ADE5C5}" dt="2024-12-03T08:35:50.402" v="34" actId="113"/>
          <ac:spMkLst>
            <pc:docMk/>
            <pc:sldMk cId="2694073638" sldId="258"/>
            <ac:spMk id="12" creationId="{14AE2807-08A6-8FD4-A044-2CD50BC9C3F1}"/>
          </ac:spMkLst>
        </pc:spChg>
        <pc:graphicFrameChg chg="add del mod">
          <ac:chgData name="Gordana Rankovic" userId="1d98097f-2084-4f17-864c-24cd5a9f1289" providerId="ADAL" clId="{79714D4F-2694-4E0F-AE29-2B0693ADE5C5}" dt="2024-12-03T08:35:42.217" v="28"/>
          <ac:graphicFrameMkLst>
            <pc:docMk/>
            <pc:sldMk cId="2694073638" sldId="258"/>
            <ac:graphicFrameMk id="2" creationId="{37D69254-4600-7619-20E7-BD9B5217AFDB}"/>
          </ac:graphicFrameMkLst>
        </pc:graphicFrameChg>
      </pc:sldChg>
      <pc:sldChg chg="addSp delSp modSp mod">
        <pc:chgData name="Gordana Rankovic" userId="1d98097f-2084-4f17-864c-24cd5a9f1289" providerId="ADAL" clId="{79714D4F-2694-4E0F-AE29-2B0693ADE5C5}" dt="2024-12-03T08:36:45.424" v="58" actId="113"/>
        <pc:sldMkLst>
          <pc:docMk/>
          <pc:sldMk cId="1279738450" sldId="259"/>
        </pc:sldMkLst>
        <pc:spChg chg="mod">
          <ac:chgData name="Gordana Rankovic" userId="1d98097f-2084-4f17-864c-24cd5a9f1289" providerId="ADAL" clId="{79714D4F-2694-4E0F-AE29-2B0693ADE5C5}" dt="2024-12-03T08:36:45.424" v="58" actId="113"/>
          <ac:spMkLst>
            <pc:docMk/>
            <pc:sldMk cId="1279738450" sldId="259"/>
            <ac:spMk id="12" creationId="{A221B00B-33F9-D802-857D-FDDDC94507CC}"/>
          </ac:spMkLst>
        </pc:spChg>
        <pc:graphicFrameChg chg="add del mod">
          <ac:chgData name="Gordana Rankovic" userId="1d98097f-2084-4f17-864c-24cd5a9f1289" providerId="ADAL" clId="{79714D4F-2694-4E0F-AE29-2B0693ADE5C5}" dt="2024-12-03T08:36:40.415" v="53"/>
          <ac:graphicFrameMkLst>
            <pc:docMk/>
            <pc:sldMk cId="1279738450" sldId="259"/>
            <ac:graphicFrameMk id="2" creationId="{4F6A781C-1AB4-4183-1229-EB30BE7BF083}"/>
          </ac:graphicFrameMkLst>
        </pc:graphicFrameChg>
      </pc:sldChg>
      <pc:sldChg chg="addSp delSp modSp mod">
        <pc:chgData name="Gordana Rankovic" userId="1d98097f-2084-4f17-864c-24cd5a9f1289" providerId="ADAL" clId="{79714D4F-2694-4E0F-AE29-2B0693ADE5C5}" dt="2024-12-03T08:36:17.258" v="46" actId="113"/>
        <pc:sldMkLst>
          <pc:docMk/>
          <pc:sldMk cId="952439907" sldId="260"/>
        </pc:sldMkLst>
        <pc:spChg chg="mod">
          <ac:chgData name="Gordana Rankovic" userId="1d98097f-2084-4f17-864c-24cd5a9f1289" providerId="ADAL" clId="{79714D4F-2694-4E0F-AE29-2B0693ADE5C5}" dt="2024-12-03T08:36:17.258" v="46" actId="113"/>
          <ac:spMkLst>
            <pc:docMk/>
            <pc:sldMk cId="952439907" sldId="260"/>
            <ac:spMk id="12" creationId="{EBD963EC-80A7-8667-59C5-AECE26E03A8A}"/>
          </ac:spMkLst>
        </pc:spChg>
        <pc:graphicFrameChg chg="add del mod">
          <ac:chgData name="Gordana Rankovic" userId="1d98097f-2084-4f17-864c-24cd5a9f1289" providerId="ADAL" clId="{79714D4F-2694-4E0F-AE29-2B0693ADE5C5}" dt="2024-12-03T08:36:13.702" v="42"/>
          <ac:graphicFrameMkLst>
            <pc:docMk/>
            <pc:sldMk cId="952439907" sldId="260"/>
            <ac:graphicFrameMk id="2" creationId="{A361B6BD-60B1-772B-B382-055FC8D7E7C2}"/>
          </ac:graphicFrameMkLst>
        </pc:graphicFrameChg>
      </pc:sldChg>
      <pc:sldChg chg="addSp delSp modSp mod">
        <pc:chgData name="Gordana Rankovic" userId="1d98097f-2084-4f17-864c-24cd5a9f1289" providerId="ADAL" clId="{79714D4F-2694-4E0F-AE29-2B0693ADE5C5}" dt="2024-12-03T08:37:04.440" v="70" actId="113"/>
        <pc:sldMkLst>
          <pc:docMk/>
          <pc:sldMk cId="3917725084" sldId="261"/>
        </pc:sldMkLst>
        <pc:spChg chg="mod">
          <ac:chgData name="Gordana Rankovic" userId="1d98097f-2084-4f17-864c-24cd5a9f1289" providerId="ADAL" clId="{79714D4F-2694-4E0F-AE29-2B0693ADE5C5}" dt="2024-12-03T08:37:04.440" v="70" actId="113"/>
          <ac:spMkLst>
            <pc:docMk/>
            <pc:sldMk cId="3917725084" sldId="261"/>
            <ac:spMk id="10" creationId="{6269CBD7-672D-ECD6-3CB9-9D641B3901FF}"/>
          </ac:spMkLst>
        </pc:spChg>
        <pc:graphicFrameChg chg="add del mod">
          <ac:chgData name="Gordana Rankovic" userId="1d98097f-2084-4f17-864c-24cd5a9f1289" providerId="ADAL" clId="{79714D4F-2694-4E0F-AE29-2B0693ADE5C5}" dt="2024-12-03T08:36:57.552" v="64"/>
          <ac:graphicFrameMkLst>
            <pc:docMk/>
            <pc:sldMk cId="3917725084" sldId="261"/>
            <ac:graphicFrameMk id="2" creationId="{6F4BF717-B9B1-917E-818C-70E9464A5704}"/>
          </ac:graphicFrameMkLst>
        </pc:graphicFrameChg>
      </pc:sldChg>
      <pc:sldChg chg="addSp delSp modSp mod">
        <pc:chgData name="Gordana Rankovic" userId="1d98097f-2084-4f17-864c-24cd5a9f1289" providerId="ADAL" clId="{79714D4F-2694-4E0F-AE29-2B0693ADE5C5}" dt="2024-12-03T08:35:01.679" v="10" actId="20577"/>
        <pc:sldMkLst>
          <pc:docMk/>
          <pc:sldMk cId="1558780136" sldId="262"/>
        </pc:sldMkLst>
        <pc:spChg chg="mod">
          <ac:chgData name="Gordana Rankovic" userId="1d98097f-2084-4f17-864c-24cd5a9f1289" providerId="ADAL" clId="{79714D4F-2694-4E0F-AE29-2B0693ADE5C5}" dt="2024-12-03T08:35:01.679" v="10" actId="20577"/>
          <ac:spMkLst>
            <pc:docMk/>
            <pc:sldMk cId="1558780136" sldId="262"/>
            <ac:spMk id="7" creationId="{29A57DC6-3454-EB16-8038-7F48F2662350}"/>
          </ac:spMkLst>
        </pc:spChg>
        <pc:graphicFrameChg chg="add del mod">
          <ac:chgData name="Gordana Rankovic" userId="1d98097f-2084-4f17-864c-24cd5a9f1289" providerId="ADAL" clId="{79714D4F-2694-4E0F-AE29-2B0693ADE5C5}" dt="2024-12-03T08:34:48.617" v="5"/>
          <ac:graphicFrameMkLst>
            <pc:docMk/>
            <pc:sldMk cId="1558780136" sldId="262"/>
            <ac:graphicFrameMk id="2" creationId="{5B19E6FA-8243-D89C-03B6-D3B24135CDF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2106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5252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3841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237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4479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781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257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3935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5571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1686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2698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A79B8-DF1F-3247-BAD1-3D34858C0F66}" type="datetimeFigureOut">
              <a:rPr kumimoji="1" lang="ja-JP" altLang="en-US" smtClean="0"/>
              <a:t>2024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E9185D-0D17-C743-BE6F-19D31D3197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546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9A57DC6-3454-EB16-8038-7F48F2662350}"/>
              </a:ext>
            </a:extLst>
          </p:cNvPr>
          <p:cNvSpPr txBox="1"/>
          <p:nvPr/>
        </p:nvSpPr>
        <p:spPr>
          <a:xfrm>
            <a:off x="-1" y="45012"/>
            <a:ext cx="859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Supplemental Figure S1. 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ceiver operating characteristic (ROC) curve for NLR.</a:t>
            </a:r>
            <a:endParaRPr kumimoji="1" lang="ja-JP" altLang="en-US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3F185FF-3D7B-E098-DE68-3EB6BE8FF5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57297" y="1214297"/>
            <a:ext cx="4429406" cy="4429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87801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図 29">
            <a:extLst>
              <a:ext uri="{FF2B5EF4-FFF2-40B4-BE49-F238E27FC236}">
                <a16:creationId xmlns:a16="http://schemas.microsoft.com/office/drawing/2014/main" id="{68F2E760-BA9D-136B-42F5-CBB8BE682B1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024" t="12925" r="5574" b="14618"/>
          <a:stretch/>
        </p:blipFill>
        <p:spPr>
          <a:xfrm>
            <a:off x="6316441" y="3690442"/>
            <a:ext cx="2278261" cy="1910535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D0B64817-E834-AC39-543E-51916108FB5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391" t="12509" r="5830" b="15036"/>
          <a:stretch/>
        </p:blipFill>
        <p:spPr>
          <a:xfrm>
            <a:off x="6317913" y="1571415"/>
            <a:ext cx="2275897" cy="192235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9A57DC6-3454-EB16-8038-7F48F2662350}"/>
              </a:ext>
            </a:extLst>
          </p:cNvPr>
          <p:cNvSpPr txBox="1"/>
          <p:nvPr/>
        </p:nvSpPr>
        <p:spPr>
          <a:xfrm>
            <a:off x="-1" y="45012"/>
            <a:ext cx="88695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Supplemental Figure S2. 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800" b="1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edictive marker for prognosis of pembrolizumab (age, CPS, chemotherapy).</a:t>
            </a:r>
            <a:endParaRPr kumimoji="1" lang="ja-JP" altLang="en-US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47087DD3-B5B8-4F40-7176-5A669C4018E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2634" b="15178"/>
          <a:stretch/>
        </p:blipFill>
        <p:spPr>
          <a:xfrm>
            <a:off x="479744" y="3668685"/>
            <a:ext cx="2678280" cy="1933389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78D5D525-BDA8-E1AC-FFD1-7EFBEF8D892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2633" b="15179"/>
          <a:stretch/>
        </p:blipFill>
        <p:spPr>
          <a:xfrm>
            <a:off x="459645" y="1554704"/>
            <a:ext cx="2708539" cy="195523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0DD3050-5FCA-54DF-A055-BD5F29C19F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3940" y="1184371"/>
            <a:ext cx="2708539" cy="276998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age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B36BC72-9F9E-7814-E747-D5BBEC4911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2452" y="1184370"/>
            <a:ext cx="2708539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CPS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20">
            <a:extLst>
              <a:ext uri="{FF2B5EF4-FFF2-40B4-BE49-F238E27FC236}">
                <a16:creationId xmlns:a16="http://schemas.microsoft.com/office/drawing/2014/main" id="{222BC420-1964-541E-DB9D-56A695BF930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615388" y="2391560"/>
            <a:ext cx="2034827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OS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20">
            <a:extLst>
              <a:ext uri="{FF2B5EF4-FFF2-40B4-BE49-F238E27FC236}">
                <a16:creationId xmlns:a16="http://schemas.microsoft.com/office/drawing/2014/main" id="{3F818A6E-8EF9-9623-F7D0-CF4C504A33A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619382" y="4493252"/>
            <a:ext cx="2034829" cy="277001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PFS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77775D24-73C5-900D-3065-1FBCF4EC6296}"/>
              </a:ext>
            </a:extLst>
          </p:cNvPr>
          <p:cNvSpPr/>
          <p:nvPr/>
        </p:nvSpPr>
        <p:spPr>
          <a:xfrm>
            <a:off x="623941" y="1512644"/>
            <a:ext cx="2708539" cy="203482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2B14BEA5-350A-F851-B2F9-775677C8182F}"/>
              </a:ext>
            </a:extLst>
          </p:cNvPr>
          <p:cNvSpPr/>
          <p:nvPr/>
        </p:nvSpPr>
        <p:spPr>
          <a:xfrm>
            <a:off x="623941" y="3614338"/>
            <a:ext cx="2708539" cy="203482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3B8B97F-A7D5-7345-B096-E7D342367425}"/>
              </a:ext>
            </a:extLst>
          </p:cNvPr>
          <p:cNvSpPr txBox="1"/>
          <p:nvPr/>
        </p:nvSpPr>
        <p:spPr>
          <a:xfrm>
            <a:off x="2597119" y="2612292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85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B9A32FE-4FBF-2209-21E5-50A7399377C1}"/>
              </a:ext>
            </a:extLst>
          </p:cNvPr>
          <p:cNvSpPr txBox="1"/>
          <p:nvPr/>
        </p:nvSpPr>
        <p:spPr>
          <a:xfrm>
            <a:off x="2619497" y="4998465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707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F3D61AA1-CFD4-6BA7-29FB-6E8829170C8D}"/>
              </a:ext>
            </a:extLst>
          </p:cNvPr>
          <p:cNvSpPr/>
          <p:nvPr/>
        </p:nvSpPr>
        <p:spPr>
          <a:xfrm>
            <a:off x="3392452" y="1512809"/>
            <a:ext cx="2708539" cy="20346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3BDE3EF6-D6DF-3B40-D22E-CD57D3230A3F}"/>
              </a:ext>
            </a:extLst>
          </p:cNvPr>
          <p:cNvSpPr/>
          <p:nvPr/>
        </p:nvSpPr>
        <p:spPr>
          <a:xfrm>
            <a:off x="3392452" y="3614338"/>
            <a:ext cx="2708539" cy="20346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99DCF564-BEA7-9B4A-24F8-2BC36687925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892" t="11300" r="5886" b="18113"/>
          <a:stretch/>
        </p:blipFill>
        <p:spPr>
          <a:xfrm>
            <a:off x="3457364" y="1549654"/>
            <a:ext cx="2419781" cy="1958252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AC34392C-F28B-A832-DEAB-C7199AFD82D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198" t="12662" r="5319" b="18136"/>
          <a:stretch/>
        </p:blipFill>
        <p:spPr>
          <a:xfrm>
            <a:off x="3525715" y="3713690"/>
            <a:ext cx="2332789" cy="1888475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113E476-B901-3BB4-4A04-AA19F06EA371}"/>
              </a:ext>
            </a:extLst>
          </p:cNvPr>
          <p:cNvSpPr txBox="1"/>
          <p:nvPr/>
        </p:nvSpPr>
        <p:spPr>
          <a:xfrm>
            <a:off x="5367878" y="4875354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27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E424511-8D0B-8E19-8454-7498A24316E9}"/>
              </a:ext>
            </a:extLst>
          </p:cNvPr>
          <p:cNvSpPr txBox="1"/>
          <p:nvPr/>
        </p:nvSpPr>
        <p:spPr>
          <a:xfrm>
            <a:off x="5319495" y="2735402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2333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14EB5BA-CB24-727A-0E81-0E487EB650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60964" y="1184369"/>
            <a:ext cx="2708539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chemo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B6CDB875-DF08-512C-FBCE-DFC22C2546DB}"/>
              </a:ext>
            </a:extLst>
          </p:cNvPr>
          <p:cNvSpPr/>
          <p:nvPr/>
        </p:nvSpPr>
        <p:spPr>
          <a:xfrm>
            <a:off x="6165955" y="3614338"/>
            <a:ext cx="2708539" cy="20346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C01C63D3-1B3D-5F36-995E-B17DED634E0D}"/>
              </a:ext>
            </a:extLst>
          </p:cNvPr>
          <p:cNvSpPr/>
          <p:nvPr/>
        </p:nvSpPr>
        <p:spPr>
          <a:xfrm>
            <a:off x="6160964" y="1512809"/>
            <a:ext cx="2708539" cy="20346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822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図 35">
            <a:extLst>
              <a:ext uri="{FF2B5EF4-FFF2-40B4-BE49-F238E27FC236}">
                <a16:creationId xmlns:a16="http://schemas.microsoft.com/office/drawing/2014/main" id="{155A379B-62A7-4E0C-13F3-CD07A874EA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693" t="14256" r="6632" b="14485"/>
          <a:stretch/>
        </p:blipFill>
        <p:spPr>
          <a:xfrm>
            <a:off x="6266539" y="3637537"/>
            <a:ext cx="2294343" cy="1953923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205E8DE1-757C-748B-D0A2-5E13EBD6FD6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007" t="14019" r="5273" b="15007"/>
          <a:stretch/>
        </p:blipFill>
        <p:spPr>
          <a:xfrm>
            <a:off x="3541104" y="3650944"/>
            <a:ext cx="2331231" cy="1930207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002EEAFA-9A46-F120-29D2-1FCD3ABC2A7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075" t="13963" r="4081" b="14339"/>
          <a:stretch/>
        </p:blipFill>
        <p:spPr>
          <a:xfrm>
            <a:off x="826783" y="3661744"/>
            <a:ext cx="2369230" cy="1956026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82B4E150-59AB-B2CC-ED8B-512A22BABE1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244" t="12915" r="4702" b="14636"/>
          <a:stretch/>
        </p:blipFill>
        <p:spPr>
          <a:xfrm>
            <a:off x="6243999" y="1493321"/>
            <a:ext cx="2369229" cy="1994647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161EE872-912B-5334-389E-E55B475C622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032" t="12379" r="3553" b="14556"/>
          <a:stretch/>
        </p:blipFill>
        <p:spPr>
          <a:xfrm>
            <a:off x="3539683" y="1499917"/>
            <a:ext cx="2369229" cy="1980194"/>
          </a:xfrm>
          <a:prstGeom prst="rect">
            <a:avLst/>
          </a:prstGeom>
        </p:spPr>
      </p:pic>
      <p:sp>
        <p:nvSpPr>
          <p:cNvPr id="3" name="テキスト ボックス 20">
            <a:extLst>
              <a:ext uri="{FF2B5EF4-FFF2-40B4-BE49-F238E27FC236}">
                <a16:creationId xmlns:a16="http://schemas.microsoft.com/office/drawing/2014/main" id="{EB5D1AC6-80A1-B32F-0E21-F7C42F22F73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07596" y="2338847"/>
            <a:ext cx="2060955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OS (alone)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20">
            <a:extLst>
              <a:ext uri="{FF2B5EF4-FFF2-40B4-BE49-F238E27FC236}">
                <a16:creationId xmlns:a16="http://schemas.microsoft.com/office/drawing/2014/main" id="{52BBA0CE-6CCA-3058-EA7D-50516109048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11930" y="4462568"/>
            <a:ext cx="2060956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OS (combo)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20">
            <a:extLst>
              <a:ext uri="{FF2B5EF4-FFF2-40B4-BE49-F238E27FC236}">
                <a16:creationId xmlns:a16="http://schemas.microsoft.com/office/drawing/2014/main" id="{488E59D1-F83D-BF73-F218-D1D4E692BF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22973" y="1116373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ALB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20">
            <a:extLst>
              <a:ext uri="{FF2B5EF4-FFF2-40B4-BE49-F238E27FC236}">
                <a16:creationId xmlns:a16="http://schemas.microsoft.com/office/drawing/2014/main" id="{007AEF79-E793-EBD5-22C2-D67C77922C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42113" y="1116373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Lymphocytes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36CC9AE7-0DC9-ADE8-74D3-6B7F266BF39F}"/>
              </a:ext>
            </a:extLst>
          </p:cNvPr>
          <p:cNvSpPr/>
          <p:nvPr/>
        </p:nvSpPr>
        <p:spPr>
          <a:xfrm>
            <a:off x="6135967" y="1447861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C5978564-DC7D-04DB-8A9C-79957CBE1402}"/>
              </a:ext>
            </a:extLst>
          </p:cNvPr>
          <p:cNvSpPr/>
          <p:nvPr/>
        </p:nvSpPr>
        <p:spPr>
          <a:xfrm>
            <a:off x="3427565" y="3564282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A2341187-8EDD-5071-A68C-E532F1BF5A88}"/>
              </a:ext>
            </a:extLst>
          </p:cNvPr>
          <p:cNvSpPr/>
          <p:nvPr/>
        </p:nvSpPr>
        <p:spPr>
          <a:xfrm>
            <a:off x="3427565" y="1445005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5BBBA139-2E65-96C0-34D3-BC20D4B09F1B}"/>
              </a:ext>
            </a:extLst>
          </p:cNvPr>
          <p:cNvSpPr/>
          <p:nvPr/>
        </p:nvSpPr>
        <p:spPr>
          <a:xfrm>
            <a:off x="713245" y="3570589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4CD959C2-BECB-27D1-7027-CD6C786BCCC3}"/>
              </a:ext>
            </a:extLst>
          </p:cNvPr>
          <p:cNvSpPr/>
          <p:nvPr/>
        </p:nvSpPr>
        <p:spPr>
          <a:xfrm>
            <a:off x="719163" y="1445005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88D45F09-C042-CCDC-6259-1689DB9E1825}"/>
              </a:ext>
            </a:extLst>
          </p:cNvPr>
          <p:cNvSpPr/>
          <p:nvPr/>
        </p:nvSpPr>
        <p:spPr>
          <a:xfrm>
            <a:off x="6142114" y="3562593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2086A2AC-C2A5-8E70-0A5D-967D407FF86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8176" t="12658" r="3582" b="14955"/>
          <a:stretch/>
        </p:blipFill>
        <p:spPr>
          <a:xfrm>
            <a:off x="814703" y="1502083"/>
            <a:ext cx="2412721" cy="1979217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BE14CCE-088F-77D9-A019-FF6453B68093}"/>
              </a:ext>
            </a:extLst>
          </p:cNvPr>
          <p:cNvSpPr txBox="1"/>
          <p:nvPr/>
        </p:nvSpPr>
        <p:spPr>
          <a:xfrm>
            <a:off x="2442785" y="2499154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3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2739D3D-E711-8DF7-2F89-BE270530D3B7}"/>
              </a:ext>
            </a:extLst>
          </p:cNvPr>
          <p:cNvSpPr txBox="1"/>
          <p:nvPr/>
        </p:nvSpPr>
        <p:spPr>
          <a:xfrm>
            <a:off x="5230699" y="2674926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88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DDB7215-B952-9896-6F81-26AC72AD8046}"/>
              </a:ext>
            </a:extLst>
          </p:cNvPr>
          <p:cNvSpPr txBox="1"/>
          <p:nvPr/>
        </p:nvSpPr>
        <p:spPr>
          <a:xfrm>
            <a:off x="7795278" y="2268614"/>
            <a:ext cx="8803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619*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585E774-2763-DC6B-ADD5-ECC029BF9A02}"/>
              </a:ext>
            </a:extLst>
          </p:cNvPr>
          <p:cNvSpPr txBox="1"/>
          <p:nvPr/>
        </p:nvSpPr>
        <p:spPr>
          <a:xfrm>
            <a:off x="2415778" y="4601546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26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B0CD1AF-729E-BAE1-938A-E2505FF8B643}"/>
              </a:ext>
            </a:extLst>
          </p:cNvPr>
          <p:cNvSpPr txBox="1"/>
          <p:nvPr/>
        </p:nvSpPr>
        <p:spPr>
          <a:xfrm>
            <a:off x="5058255" y="4694177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72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889AD48-EE50-93AC-A74B-A49542728A4A}"/>
              </a:ext>
            </a:extLst>
          </p:cNvPr>
          <p:cNvSpPr txBox="1"/>
          <p:nvPr/>
        </p:nvSpPr>
        <p:spPr>
          <a:xfrm>
            <a:off x="7708683" y="4383346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439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9" name="図 38">
            <a:extLst>
              <a:ext uri="{FF2B5EF4-FFF2-40B4-BE49-F238E27FC236}">
                <a16:creationId xmlns:a16="http://schemas.microsoft.com/office/drawing/2014/main" id="{46024EF6-D406-4EAD-A8CE-E761CBA8109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51990" y="3674136"/>
            <a:ext cx="288935" cy="1585236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F8247CB0-BD1B-97DC-2449-0C3DE7DF001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52971" y="3653062"/>
            <a:ext cx="291617" cy="1599953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BF3D2C64-9505-5835-F8F6-9A302711844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26783" y="3679913"/>
            <a:ext cx="288935" cy="1585236"/>
          </a:xfrm>
          <a:prstGeom prst="rect">
            <a:avLst/>
          </a:prstGeom>
        </p:spPr>
      </p:pic>
      <p:sp>
        <p:nvSpPr>
          <p:cNvPr id="9" name="テキスト ボックス 20">
            <a:extLst>
              <a:ext uri="{FF2B5EF4-FFF2-40B4-BE49-F238E27FC236}">
                <a16:creationId xmlns:a16="http://schemas.microsoft.com/office/drawing/2014/main" id="{855119C0-F7C2-D4C7-72BB-2C54610F29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5187" y="1116373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CRP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4AE2807-08A6-8FD4-A044-2CD50BC9C3F1}"/>
              </a:ext>
            </a:extLst>
          </p:cNvPr>
          <p:cNvSpPr txBox="1"/>
          <p:nvPr/>
        </p:nvSpPr>
        <p:spPr>
          <a:xfrm>
            <a:off x="10277" y="44143"/>
            <a:ext cx="90690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Supplemental Figure S3. 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 predictive marker for OS of pembrolizumab (CRP, ALB, lymphocytes)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940736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図 36">
            <a:extLst>
              <a:ext uri="{FF2B5EF4-FFF2-40B4-BE49-F238E27FC236}">
                <a16:creationId xmlns:a16="http://schemas.microsoft.com/office/drawing/2014/main" id="{28BD5896-CF0E-3C18-A4E8-289A09BD12A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509" t="13796" r="5622" b="14776"/>
          <a:stretch/>
        </p:blipFill>
        <p:spPr>
          <a:xfrm>
            <a:off x="6254256" y="3570478"/>
            <a:ext cx="2320489" cy="1953003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D0552828-0143-E063-5D73-6AF2F37F724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206" t="13043" r="5761" b="14649"/>
          <a:stretch/>
        </p:blipFill>
        <p:spPr>
          <a:xfrm>
            <a:off x="3549623" y="3551854"/>
            <a:ext cx="2325050" cy="1977117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12C7623F-6FA7-147A-104C-B43BAB56DE7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983" t="13043" r="6092" b="14649"/>
          <a:stretch/>
        </p:blipFill>
        <p:spPr>
          <a:xfrm>
            <a:off x="851862" y="3581210"/>
            <a:ext cx="2294335" cy="1953486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66FF1581-9D8F-C6D4-618F-2869CF18E09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051" t="13166" r="5812" b="14942"/>
          <a:stretch/>
        </p:blipFill>
        <p:spPr>
          <a:xfrm>
            <a:off x="6247784" y="1446856"/>
            <a:ext cx="2325050" cy="1963341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33797B83-B4FD-093E-5732-D7A83578FB8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944" t="13675" r="6022" b="14386"/>
          <a:stretch/>
        </p:blipFill>
        <p:spPr>
          <a:xfrm>
            <a:off x="3541697" y="1419429"/>
            <a:ext cx="2375380" cy="2009571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293DDAB6-DE1B-AE98-3A40-0A6D551CD76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8784" t="13501" r="3571" b="14605"/>
          <a:stretch/>
        </p:blipFill>
        <p:spPr>
          <a:xfrm>
            <a:off x="819987" y="1448613"/>
            <a:ext cx="2386266" cy="1957401"/>
          </a:xfrm>
          <a:prstGeom prst="rect">
            <a:avLst/>
          </a:prstGeom>
        </p:spPr>
      </p:pic>
      <p:sp>
        <p:nvSpPr>
          <p:cNvPr id="3" name="テキスト ボックス 20">
            <a:extLst>
              <a:ext uri="{FF2B5EF4-FFF2-40B4-BE49-F238E27FC236}">
                <a16:creationId xmlns:a16="http://schemas.microsoft.com/office/drawing/2014/main" id="{EB5D1AC6-80A1-B32F-0E21-F7C42F22F73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11045" y="2276319"/>
            <a:ext cx="2060955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PFS (alone)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20">
            <a:extLst>
              <a:ext uri="{FF2B5EF4-FFF2-40B4-BE49-F238E27FC236}">
                <a16:creationId xmlns:a16="http://schemas.microsoft.com/office/drawing/2014/main" id="{52BBA0CE-6CCA-3058-EA7D-50516109048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15379" y="4400041"/>
            <a:ext cx="2060956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PFS (combo)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20">
            <a:extLst>
              <a:ext uri="{FF2B5EF4-FFF2-40B4-BE49-F238E27FC236}">
                <a16:creationId xmlns:a16="http://schemas.microsoft.com/office/drawing/2014/main" id="{488E59D1-F83D-BF73-F218-D1D4E692BF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9299" y="1050762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ALB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20">
            <a:extLst>
              <a:ext uri="{FF2B5EF4-FFF2-40B4-BE49-F238E27FC236}">
                <a16:creationId xmlns:a16="http://schemas.microsoft.com/office/drawing/2014/main" id="{007AEF79-E793-EBD5-22C2-D67C77922C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23933" y="1050761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Lymphocytes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8EF0E7FF-B2DA-9153-B666-6C60E6524FAF}"/>
              </a:ext>
            </a:extLst>
          </p:cNvPr>
          <p:cNvSpPr/>
          <p:nvPr/>
        </p:nvSpPr>
        <p:spPr>
          <a:xfrm>
            <a:off x="6123933" y="1376633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C38F3921-F4B8-F92F-7DB4-394C1ABB8E39}"/>
              </a:ext>
            </a:extLst>
          </p:cNvPr>
          <p:cNvSpPr/>
          <p:nvPr/>
        </p:nvSpPr>
        <p:spPr>
          <a:xfrm>
            <a:off x="3419300" y="3502981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EBF7CA31-F6DB-8C65-773B-7B68244D2B51}"/>
              </a:ext>
            </a:extLst>
          </p:cNvPr>
          <p:cNvSpPr/>
          <p:nvPr/>
        </p:nvSpPr>
        <p:spPr>
          <a:xfrm>
            <a:off x="3421213" y="1376343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4F04D56F-3C75-917D-F81C-9A12660AFA50}"/>
              </a:ext>
            </a:extLst>
          </p:cNvPr>
          <p:cNvSpPr/>
          <p:nvPr/>
        </p:nvSpPr>
        <p:spPr>
          <a:xfrm>
            <a:off x="721540" y="3502981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58F9408A-696A-F5F9-485B-D8F234C968F4}"/>
              </a:ext>
            </a:extLst>
          </p:cNvPr>
          <p:cNvSpPr/>
          <p:nvPr/>
        </p:nvSpPr>
        <p:spPr>
          <a:xfrm>
            <a:off x="721540" y="1381535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5CD81499-254E-03B3-0F58-2085CDB3C1F2}"/>
              </a:ext>
            </a:extLst>
          </p:cNvPr>
          <p:cNvSpPr/>
          <p:nvPr/>
        </p:nvSpPr>
        <p:spPr>
          <a:xfrm>
            <a:off x="6123933" y="3502981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ED4BF08-18B8-0241-EAC2-112F74CF0DA2}"/>
              </a:ext>
            </a:extLst>
          </p:cNvPr>
          <p:cNvSpPr txBox="1"/>
          <p:nvPr/>
        </p:nvSpPr>
        <p:spPr>
          <a:xfrm>
            <a:off x="2518244" y="2302672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612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AA7A733-0B02-57F2-1D5D-FEB27C5BAAE7}"/>
              </a:ext>
            </a:extLst>
          </p:cNvPr>
          <p:cNvSpPr txBox="1"/>
          <p:nvPr/>
        </p:nvSpPr>
        <p:spPr>
          <a:xfrm>
            <a:off x="5170986" y="2397797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765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E0E4350-D308-4087-F074-5DC8F01D4384}"/>
              </a:ext>
            </a:extLst>
          </p:cNvPr>
          <p:cNvSpPr txBox="1"/>
          <p:nvPr/>
        </p:nvSpPr>
        <p:spPr>
          <a:xfrm>
            <a:off x="7805526" y="2534569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344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1A2D561-4449-9F9D-1337-7FD3ACD57297}"/>
              </a:ext>
            </a:extLst>
          </p:cNvPr>
          <p:cNvSpPr txBox="1"/>
          <p:nvPr/>
        </p:nvSpPr>
        <p:spPr>
          <a:xfrm>
            <a:off x="2420222" y="4341422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67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88FBF7E-06FD-CF76-C149-BCBCA421D074}"/>
              </a:ext>
            </a:extLst>
          </p:cNvPr>
          <p:cNvSpPr txBox="1"/>
          <p:nvPr/>
        </p:nvSpPr>
        <p:spPr>
          <a:xfrm>
            <a:off x="5254934" y="4665413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323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EFAF4CB-37F4-6D83-6359-17666F87C0EC}"/>
              </a:ext>
            </a:extLst>
          </p:cNvPr>
          <p:cNvSpPr txBox="1"/>
          <p:nvPr/>
        </p:nvSpPr>
        <p:spPr>
          <a:xfrm>
            <a:off x="7890236" y="4566774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41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2" name="図 41">
            <a:extLst>
              <a:ext uri="{FF2B5EF4-FFF2-40B4-BE49-F238E27FC236}">
                <a16:creationId xmlns:a16="http://schemas.microsoft.com/office/drawing/2014/main" id="{6C817FD4-3E5A-2C81-44F3-732B36942FA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4874" y="3619426"/>
            <a:ext cx="269253" cy="1650947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03B3F374-EA10-8265-15A3-6971AD43E36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59159" y="3591131"/>
            <a:ext cx="272844" cy="1672966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C48E0EF4-2AA7-24B0-0B60-39BC5F2953F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57919" y="3592781"/>
            <a:ext cx="272844" cy="1672966"/>
          </a:xfrm>
          <a:prstGeom prst="rect">
            <a:avLst/>
          </a:prstGeom>
        </p:spPr>
      </p:pic>
      <p:sp>
        <p:nvSpPr>
          <p:cNvPr id="10" name="テキスト ボックス 20">
            <a:extLst>
              <a:ext uri="{FF2B5EF4-FFF2-40B4-BE49-F238E27FC236}">
                <a16:creationId xmlns:a16="http://schemas.microsoft.com/office/drawing/2014/main" id="{CF2E22CC-07FA-200C-52C9-76E655D1F3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4665" y="1050762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CPR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BD963EC-80A7-8667-59C5-AECE26E03A8A}"/>
              </a:ext>
            </a:extLst>
          </p:cNvPr>
          <p:cNvSpPr txBox="1"/>
          <p:nvPr/>
        </p:nvSpPr>
        <p:spPr>
          <a:xfrm>
            <a:off x="-49935" y="9637"/>
            <a:ext cx="88244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Supplemental Figure S4. 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 predictive marker for PFS of pembrolizumab (CRP, ALB, lymphocytes)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524399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図 35">
            <a:extLst>
              <a:ext uri="{FF2B5EF4-FFF2-40B4-BE49-F238E27FC236}">
                <a16:creationId xmlns:a16="http://schemas.microsoft.com/office/drawing/2014/main" id="{29D5F60F-751A-2E4C-0676-DF47E564316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874" t="13148" r="6583" b="21425"/>
          <a:stretch/>
        </p:blipFill>
        <p:spPr>
          <a:xfrm>
            <a:off x="6239531" y="3836525"/>
            <a:ext cx="2392474" cy="1851497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328FDC62-3905-11FE-7D11-B5FA440E107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477" t="13766" r="5535" b="17588"/>
          <a:stretch/>
        </p:blipFill>
        <p:spPr>
          <a:xfrm>
            <a:off x="3540481" y="3836132"/>
            <a:ext cx="2396629" cy="1913268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0970FBD9-72A0-7B16-4C33-C7BFA1F5992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095" t="13689" r="6280" b="14439"/>
          <a:stretch/>
        </p:blipFill>
        <p:spPr>
          <a:xfrm>
            <a:off x="838772" y="3817199"/>
            <a:ext cx="2297430" cy="1928417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3497CF40-EA80-B767-2622-99CD7826AB5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237" t="13848" r="4862" b="21241"/>
          <a:stretch/>
        </p:blipFill>
        <p:spPr>
          <a:xfrm>
            <a:off x="6191651" y="1740067"/>
            <a:ext cx="2463608" cy="1840179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A61D4BD7-E907-703B-4F82-49258DDEA1E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164" t="13864" r="6142" b="18080"/>
          <a:stretch/>
        </p:blipFill>
        <p:spPr>
          <a:xfrm>
            <a:off x="3548199" y="1727683"/>
            <a:ext cx="2309733" cy="185599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0DA0E97D-021E-D2E7-3E16-B540EF0A2C6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552" t="14055" r="4893" b="14856"/>
          <a:stretch/>
        </p:blipFill>
        <p:spPr>
          <a:xfrm>
            <a:off x="804250" y="1669143"/>
            <a:ext cx="2398441" cy="1947380"/>
          </a:xfrm>
          <a:prstGeom prst="rect">
            <a:avLst/>
          </a:prstGeom>
        </p:spPr>
      </p:pic>
      <p:sp>
        <p:nvSpPr>
          <p:cNvPr id="3" name="テキスト ボックス 20">
            <a:extLst>
              <a:ext uri="{FF2B5EF4-FFF2-40B4-BE49-F238E27FC236}">
                <a16:creationId xmlns:a16="http://schemas.microsoft.com/office/drawing/2014/main" id="{EB5D1AC6-80A1-B32F-0E21-F7C42F22F73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488742" y="2485791"/>
            <a:ext cx="2060955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OS (alone)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20">
            <a:extLst>
              <a:ext uri="{FF2B5EF4-FFF2-40B4-BE49-F238E27FC236}">
                <a16:creationId xmlns:a16="http://schemas.microsoft.com/office/drawing/2014/main" id="{52BBA0CE-6CCA-3058-EA7D-50516109048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493076" y="4609513"/>
            <a:ext cx="2060956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OS (combo)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20">
            <a:extLst>
              <a:ext uri="{FF2B5EF4-FFF2-40B4-BE49-F238E27FC236}">
                <a16:creationId xmlns:a16="http://schemas.microsoft.com/office/drawing/2014/main" id="{1BBE08D5-863B-C6B7-84E8-4122FC042B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5555" y="1260234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NLR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20">
            <a:extLst>
              <a:ext uri="{FF2B5EF4-FFF2-40B4-BE49-F238E27FC236}">
                <a16:creationId xmlns:a16="http://schemas.microsoft.com/office/drawing/2014/main" id="{488E59D1-F83D-BF73-F218-D1D4E692BF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1231" y="1260233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 err="1">
                <a:ea typeface="Meiryo" panose="020B0604030504040204" pitchFamily="34" charset="-128"/>
                <a:cs typeface="Arial" panose="020B0604020202020204" pitchFamily="34" charset="0"/>
              </a:rPr>
              <a:t>mGPS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20">
            <a:extLst>
              <a:ext uri="{FF2B5EF4-FFF2-40B4-BE49-F238E27FC236}">
                <a16:creationId xmlns:a16="http://schemas.microsoft.com/office/drawing/2014/main" id="{007AEF79-E793-EBD5-22C2-D67C77922C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52450" y="1260233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 err="1">
                <a:ea typeface="Meiryo" panose="020B0604030504040204" pitchFamily="34" charset="-128"/>
                <a:cs typeface="Arial" panose="020B0604020202020204" pitchFamily="34" charset="0"/>
              </a:rPr>
              <a:t>imGPS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FD9B2E50-067E-8715-9255-F49FCAF57C5C}"/>
              </a:ext>
            </a:extLst>
          </p:cNvPr>
          <p:cNvSpPr/>
          <p:nvPr/>
        </p:nvSpPr>
        <p:spPr>
          <a:xfrm>
            <a:off x="6144732" y="1591007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E42ECE0-755E-5CA4-31F8-A735B015AE5A}"/>
              </a:ext>
            </a:extLst>
          </p:cNvPr>
          <p:cNvSpPr/>
          <p:nvPr/>
        </p:nvSpPr>
        <p:spPr>
          <a:xfrm>
            <a:off x="3441398" y="3709538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7822F21D-1EE1-E052-B495-A43412740398}"/>
              </a:ext>
            </a:extLst>
          </p:cNvPr>
          <p:cNvSpPr/>
          <p:nvPr/>
        </p:nvSpPr>
        <p:spPr>
          <a:xfrm>
            <a:off x="3441231" y="1585815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FC9C2686-64E8-F45A-9928-8B6FDED6F93D}"/>
              </a:ext>
            </a:extLst>
          </p:cNvPr>
          <p:cNvSpPr/>
          <p:nvPr/>
        </p:nvSpPr>
        <p:spPr>
          <a:xfrm>
            <a:off x="735556" y="3717534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3F43C4A5-A062-4957-291F-57D7B340C8E4}"/>
              </a:ext>
            </a:extLst>
          </p:cNvPr>
          <p:cNvSpPr/>
          <p:nvPr/>
        </p:nvSpPr>
        <p:spPr>
          <a:xfrm>
            <a:off x="740826" y="1591007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72EF89B9-9D8B-88DB-323B-E8320CFE02DB}"/>
              </a:ext>
            </a:extLst>
          </p:cNvPr>
          <p:cNvSpPr/>
          <p:nvPr/>
        </p:nvSpPr>
        <p:spPr>
          <a:xfrm>
            <a:off x="6144732" y="3709538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3D03C21-D077-C753-3269-53063154819D}"/>
              </a:ext>
            </a:extLst>
          </p:cNvPr>
          <p:cNvSpPr txBox="1"/>
          <p:nvPr/>
        </p:nvSpPr>
        <p:spPr>
          <a:xfrm>
            <a:off x="2558495" y="2713206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735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5A9929D-0CC5-69A5-2973-640FC240BF9C}"/>
              </a:ext>
            </a:extLst>
          </p:cNvPr>
          <p:cNvSpPr txBox="1"/>
          <p:nvPr/>
        </p:nvSpPr>
        <p:spPr>
          <a:xfrm>
            <a:off x="5121768" y="2660364"/>
            <a:ext cx="9444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69**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9B3C786-A916-48E5-737F-CEBD00D13D03}"/>
              </a:ext>
            </a:extLst>
          </p:cNvPr>
          <p:cNvSpPr txBox="1"/>
          <p:nvPr/>
        </p:nvSpPr>
        <p:spPr>
          <a:xfrm>
            <a:off x="7821183" y="2612894"/>
            <a:ext cx="9444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74**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F071E8B-17F4-8B12-F31F-9E53723D5540}"/>
              </a:ext>
            </a:extLst>
          </p:cNvPr>
          <p:cNvSpPr txBox="1"/>
          <p:nvPr/>
        </p:nvSpPr>
        <p:spPr>
          <a:xfrm>
            <a:off x="2582650" y="4858163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495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0DF86CB-9FAB-F7ED-78D2-2DA18F834C37}"/>
              </a:ext>
            </a:extLst>
          </p:cNvPr>
          <p:cNvSpPr txBox="1"/>
          <p:nvPr/>
        </p:nvSpPr>
        <p:spPr>
          <a:xfrm>
            <a:off x="5152661" y="4770594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444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3A3CA19-6148-8C31-D469-6450BB689C59}"/>
              </a:ext>
            </a:extLst>
          </p:cNvPr>
          <p:cNvSpPr txBox="1"/>
          <p:nvPr/>
        </p:nvSpPr>
        <p:spPr>
          <a:xfrm>
            <a:off x="7974675" y="4744014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08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9" name="図 38">
            <a:extLst>
              <a:ext uri="{FF2B5EF4-FFF2-40B4-BE49-F238E27FC236}">
                <a16:creationId xmlns:a16="http://schemas.microsoft.com/office/drawing/2014/main" id="{C76119C2-84D1-F377-5E59-3BC5C36D72E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5005" y="3817199"/>
            <a:ext cx="316155" cy="1601172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A120628E-41B4-F4ED-4A71-66D0C0D684B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63729" y="3858598"/>
            <a:ext cx="290929" cy="1473415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C864FEDC-6F7B-768D-7294-49D523F2332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44615" y="3846694"/>
            <a:ext cx="306710" cy="1553338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221B00B-33F9-D802-857D-FDDDC94507CC}"/>
              </a:ext>
            </a:extLst>
          </p:cNvPr>
          <p:cNvSpPr txBox="1"/>
          <p:nvPr/>
        </p:nvSpPr>
        <p:spPr>
          <a:xfrm>
            <a:off x="10276" y="44143"/>
            <a:ext cx="87165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Supplemental Figure S5. 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 predictive marker for OS of pembrolizumab (NLR, </a:t>
            </a:r>
            <a:r>
              <a:rPr lang="en-US" sz="1800" spc="-1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GPS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800" spc="-1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mGPS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797384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図 35">
            <a:extLst>
              <a:ext uri="{FF2B5EF4-FFF2-40B4-BE49-F238E27FC236}">
                <a16:creationId xmlns:a16="http://schemas.microsoft.com/office/drawing/2014/main" id="{ABA8FC24-1A41-711D-A761-9AD90387C8D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29" t="13569" r="6139" b="21904"/>
          <a:stretch/>
        </p:blipFill>
        <p:spPr>
          <a:xfrm>
            <a:off x="6222773" y="3865321"/>
            <a:ext cx="2444681" cy="1850776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8AC9AFC1-012A-22C2-1554-98D7DAC3666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722" t="14049" r="4412" b="18534"/>
          <a:stretch/>
        </p:blipFill>
        <p:spPr>
          <a:xfrm>
            <a:off x="3558965" y="3799558"/>
            <a:ext cx="2461429" cy="1910338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A0357000-CB21-AAF8-C7EF-99A8859C223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415" t="14144" r="4622" b="14161"/>
          <a:stretch/>
        </p:blipFill>
        <p:spPr>
          <a:xfrm>
            <a:off x="851059" y="3799766"/>
            <a:ext cx="2342705" cy="1931367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21E82B94-A2E2-10D7-5669-079170F29E5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415" t="13105" r="6258" b="21425"/>
          <a:stretch/>
        </p:blipFill>
        <p:spPr>
          <a:xfrm>
            <a:off x="6178437" y="1677850"/>
            <a:ext cx="2510717" cy="1926388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1BCFB1E4-0439-DE35-0876-6C0EB52D716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002" t="13306" r="4228" b="17679"/>
          <a:stretch/>
        </p:blipFill>
        <p:spPr>
          <a:xfrm>
            <a:off x="3503733" y="1687261"/>
            <a:ext cx="2443120" cy="1921089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5A344459-985C-EBC1-A25F-43852F18A65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8840" t="13098" r="5253" b="14638"/>
          <a:stretch/>
        </p:blipFill>
        <p:spPr>
          <a:xfrm>
            <a:off x="849539" y="1651376"/>
            <a:ext cx="2329023" cy="1959128"/>
          </a:xfrm>
          <a:prstGeom prst="rect">
            <a:avLst/>
          </a:prstGeom>
        </p:spPr>
      </p:pic>
      <p:sp>
        <p:nvSpPr>
          <p:cNvPr id="3" name="テキスト ボックス 20">
            <a:extLst>
              <a:ext uri="{FF2B5EF4-FFF2-40B4-BE49-F238E27FC236}">
                <a16:creationId xmlns:a16="http://schemas.microsoft.com/office/drawing/2014/main" id="{EB5D1AC6-80A1-B32F-0E21-F7C42F22F73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488742" y="2475096"/>
            <a:ext cx="2060955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PFS (alone)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20">
            <a:extLst>
              <a:ext uri="{FF2B5EF4-FFF2-40B4-BE49-F238E27FC236}">
                <a16:creationId xmlns:a16="http://schemas.microsoft.com/office/drawing/2014/main" id="{52BBA0CE-6CCA-3058-EA7D-50516109048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493076" y="4598818"/>
            <a:ext cx="2060956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PFS (combo)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20">
            <a:extLst>
              <a:ext uri="{FF2B5EF4-FFF2-40B4-BE49-F238E27FC236}">
                <a16:creationId xmlns:a16="http://schemas.microsoft.com/office/drawing/2014/main" id="{1BBE08D5-863B-C6B7-84E8-4122FC042B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5555" y="1249539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>
                <a:ea typeface="Meiryo" panose="020B0604030504040204" pitchFamily="34" charset="-128"/>
                <a:cs typeface="Arial" panose="020B0604020202020204" pitchFamily="34" charset="0"/>
              </a:rPr>
              <a:t>NLR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20">
            <a:extLst>
              <a:ext uri="{FF2B5EF4-FFF2-40B4-BE49-F238E27FC236}">
                <a16:creationId xmlns:a16="http://schemas.microsoft.com/office/drawing/2014/main" id="{488E59D1-F83D-BF73-F218-D1D4E692BF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6304" y="1249538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 err="1">
                <a:ea typeface="Meiryo" panose="020B0604030504040204" pitchFamily="34" charset="-128"/>
                <a:cs typeface="Arial" panose="020B0604020202020204" pitchFamily="34" charset="0"/>
              </a:rPr>
              <a:t>mGPS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20">
            <a:extLst>
              <a:ext uri="{FF2B5EF4-FFF2-40B4-BE49-F238E27FC236}">
                <a16:creationId xmlns:a16="http://schemas.microsoft.com/office/drawing/2014/main" id="{007AEF79-E793-EBD5-22C2-D67C77922C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57053" y="1253457"/>
            <a:ext cx="2650621" cy="27699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ja-JP" sz="1200" dirty="0" err="1">
                <a:ea typeface="Meiryo" panose="020B0604030504040204" pitchFamily="34" charset="-128"/>
                <a:cs typeface="Arial" panose="020B0604020202020204" pitchFamily="34" charset="0"/>
              </a:rPr>
              <a:t>imGPS</a:t>
            </a:r>
            <a:endParaRPr lang="ja-JP" altLang="en-US" sz="1200"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079CD1DA-C53B-B86D-B7A7-6792C1AABC72}"/>
              </a:ext>
            </a:extLst>
          </p:cNvPr>
          <p:cNvSpPr/>
          <p:nvPr/>
        </p:nvSpPr>
        <p:spPr>
          <a:xfrm>
            <a:off x="6148974" y="1580433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641E047-9E8E-C09E-8162-8733D2DF804F}"/>
              </a:ext>
            </a:extLst>
          </p:cNvPr>
          <p:cNvSpPr/>
          <p:nvPr/>
        </p:nvSpPr>
        <p:spPr>
          <a:xfrm>
            <a:off x="3441092" y="3698843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7A772563-23C8-9606-615A-186C173F22BE}"/>
              </a:ext>
            </a:extLst>
          </p:cNvPr>
          <p:cNvSpPr/>
          <p:nvPr/>
        </p:nvSpPr>
        <p:spPr>
          <a:xfrm>
            <a:off x="3446305" y="1583118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98790B40-8CDA-7531-E7EB-1D940E4A6E2F}"/>
              </a:ext>
            </a:extLst>
          </p:cNvPr>
          <p:cNvSpPr/>
          <p:nvPr/>
        </p:nvSpPr>
        <p:spPr>
          <a:xfrm>
            <a:off x="733187" y="3698843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EF5ACAE3-4822-B717-1751-1C12821CC0FD}"/>
              </a:ext>
            </a:extLst>
          </p:cNvPr>
          <p:cNvSpPr/>
          <p:nvPr/>
        </p:nvSpPr>
        <p:spPr>
          <a:xfrm>
            <a:off x="733187" y="1578214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F365FFEE-7E0A-F1F5-6B65-88D049FC7671}"/>
              </a:ext>
            </a:extLst>
          </p:cNvPr>
          <p:cNvSpPr/>
          <p:nvPr/>
        </p:nvSpPr>
        <p:spPr>
          <a:xfrm>
            <a:off x="6148974" y="3697695"/>
            <a:ext cx="2650620" cy="2068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68D108F-13CA-E2BD-31E4-CB5A57E19B2B}"/>
              </a:ext>
            </a:extLst>
          </p:cNvPr>
          <p:cNvSpPr txBox="1"/>
          <p:nvPr/>
        </p:nvSpPr>
        <p:spPr>
          <a:xfrm>
            <a:off x="2424177" y="2518052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27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6610A35-E15A-9FA8-1570-D41BDA6AD0B5}"/>
              </a:ext>
            </a:extLst>
          </p:cNvPr>
          <p:cNvSpPr txBox="1"/>
          <p:nvPr/>
        </p:nvSpPr>
        <p:spPr>
          <a:xfrm>
            <a:off x="5137295" y="2524694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419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73F8484-0182-0531-3AF2-28A185A1A29B}"/>
              </a:ext>
            </a:extLst>
          </p:cNvPr>
          <p:cNvSpPr txBox="1"/>
          <p:nvPr/>
        </p:nvSpPr>
        <p:spPr>
          <a:xfrm>
            <a:off x="7835877" y="2725708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451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7EFDE2C-55F7-E53C-959F-B5FD00F50689}"/>
              </a:ext>
            </a:extLst>
          </p:cNvPr>
          <p:cNvSpPr txBox="1"/>
          <p:nvPr/>
        </p:nvSpPr>
        <p:spPr>
          <a:xfrm>
            <a:off x="2451088" y="4709980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224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0A9C028-04E2-A799-064F-4E61B718CA8F}"/>
              </a:ext>
            </a:extLst>
          </p:cNvPr>
          <p:cNvSpPr txBox="1"/>
          <p:nvPr/>
        </p:nvSpPr>
        <p:spPr>
          <a:xfrm>
            <a:off x="5089552" y="4868691"/>
            <a:ext cx="10086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015**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F2B1F8E-23DE-152C-B3DE-B38024FF02DB}"/>
              </a:ext>
            </a:extLst>
          </p:cNvPr>
          <p:cNvSpPr txBox="1"/>
          <p:nvPr/>
        </p:nvSpPr>
        <p:spPr>
          <a:xfrm>
            <a:off x="7871054" y="4639202"/>
            <a:ext cx="8803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99**</a:t>
            </a:r>
            <a:endParaRPr kumimoji="1" lang="ja-JP" altLang="en-US" sz="10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9" name="図 38">
            <a:extLst>
              <a:ext uri="{FF2B5EF4-FFF2-40B4-BE49-F238E27FC236}">
                <a16:creationId xmlns:a16="http://schemas.microsoft.com/office/drawing/2014/main" id="{B6CAD300-C557-406C-DC3B-3ACBDCEB485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4624" y="3806298"/>
            <a:ext cx="303472" cy="1614211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C36F58A5-9C51-3A22-C102-C862C34F9D5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39491" y="3873848"/>
            <a:ext cx="286754" cy="1525284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E89C64FF-BBF5-0558-ADB3-8575DB335D2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63591" y="3794209"/>
            <a:ext cx="302041" cy="1606601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269CBD7-672D-ECD6-3CB9-9D641B3901FF}"/>
              </a:ext>
            </a:extLst>
          </p:cNvPr>
          <p:cNvSpPr txBox="1"/>
          <p:nvPr/>
        </p:nvSpPr>
        <p:spPr>
          <a:xfrm>
            <a:off x="10276" y="44143"/>
            <a:ext cx="87973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Supplemental Figure S6. 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 predictive marker for PFS of pembrolizumab (NLR, </a:t>
            </a:r>
            <a:r>
              <a:rPr lang="en-US" sz="1800" spc="-1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GPS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800" spc="-1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mGPS</a:t>
            </a:r>
            <a:r>
              <a:rPr lang="en-US" sz="1800" spc="-1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.</a:t>
            </a:r>
            <a:endParaRPr kumimoji="1"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917725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66</TotalTime>
  <Words>255</Words>
  <Application>Microsoft Office PowerPoint</Application>
  <PresentationFormat>On-screen Show (4:3)</PresentationFormat>
  <Paragraphs>5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Meiryo</vt:lpstr>
      <vt:lpstr>Arial</vt:lpstr>
      <vt:lpstr>Calibri</vt:lpstr>
      <vt:lpstr>Calibri Light</vt:lpstr>
      <vt:lpstr>Palatino Linotype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将 黒木</dc:creator>
  <cp:lastModifiedBy>MDPI-1303</cp:lastModifiedBy>
  <cp:revision>5</cp:revision>
  <dcterms:created xsi:type="dcterms:W3CDTF">2024-10-04T07:32:19Z</dcterms:created>
  <dcterms:modified xsi:type="dcterms:W3CDTF">2024-12-03T08:37:06Z</dcterms:modified>
</cp:coreProperties>
</file>